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7"/>
    <p:restoredTop sz="96327"/>
  </p:normalViewPr>
  <p:slideViewPr>
    <p:cSldViewPr snapToGrid="0" snapToObjects="1">
      <p:cViewPr varScale="1">
        <p:scale>
          <a:sx n="125" d="100"/>
          <a:sy n="125" d="100"/>
        </p:scale>
        <p:origin x="280"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C72B87DD-B296-8D42-82DD-9E467B0A2E4C}"/>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697CA786-6AEC-434A-A443-3C355CA4C54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6F0F7298-1D42-5B4B-B430-F93DF95AFC42}"/>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5" name="Segnaposto piè di pagina 4">
            <a:extLst>
              <a:ext uri="{FF2B5EF4-FFF2-40B4-BE49-F238E27FC236}">
                <a16:creationId xmlns:a16="http://schemas.microsoft.com/office/drawing/2014/main" id="{10C13E4E-CDCF-9543-A2A8-A160197301B9}"/>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EC2B4317-26FF-194C-8A7A-404EB9D66484}"/>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24585266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D1EB8434-3010-A442-B980-FFC2EABCD0F7}"/>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5D8A0CEC-7DAD-3744-B375-22E18E008477}"/>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03597AB8-F6D4-3F4D-9D0A-93C785A5B92B}"/>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5" name="Segnaposto piè di pagina 4">
            <a:extLst>
              <a:ext uri="{FF2B5EF4-FFF2-40B4-BE49-F238E27FC236}">
                <a16:creationId xmlns:a16="http://schemas.microsoft.com/office/drawing/2014/main" id="{D07F2281-492D-1E48-B4ED-13740D3BA56B}"/>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A784DF52-E190-8648-8A18-EE5B65007F49}"/>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26533198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90FDC009-57BE-9D44-8D8F-D9C522796DDC}"/>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96F5DB19-2409-B046-BF0A-64CFD0F7F70E}"/>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FEFE1503-8B60-8342-8EBD-489CCD1404F0}"/>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5" name="Segnaposto piè di pagina 4">
            <a:extLst>
              <a:ext uri="{FF2B5EF4-FFF2-40B4-BE49-F238E27FC236}">
                <a16:creationId xmlns:a16="http://schemas.microsoft.com/office/drawing/2014/main" id="{0A297E7D-90B2-6447-AAEE-185C0C532A4C}"/>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AAEC44B7-ADD8-3F44-B9A3-7882C324658D}"/>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18665932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A05431D-E305-C642-A0BA-D958E0535D85}"/>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874735BB-77EB-5F45-A52D-0D0993BD5811}"/>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3340BF67-5A9E-0B4A-9FC6-AF927C962A2B}"/>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5" name="Segnaposto piè di pagina 4">
            <a:extLst>
              <a:ext uri="{FF2B5EF4-FFF2-40B4-BE49-F238E27FC236}">
                <a16:creationId xmlns:a16="http://schemas.microsoft.com/office/drawing/2014/main" id="{26FEF717-49A6-1342-ADCD-9D24418581CF}"/>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715F25E4-E865-8347-BD57-B090B304E983}"/>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13025194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9CE5D3B-618C-AE4E-B65E-B60ADA07BEDE}"/>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9E7C7A2F-BAD7-2B48-BD7E-304064776F9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D07D1FC6-698A-5E4A-B447-543C9A1EF069}"/>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5" name="Segnaposto piè di pagina 4">
            <a:extLst>
              <a:ext uri="{FF2B5EF4-FFF2-40B4-BE49-F238E27FC236}">
                <a16:creationId xmlns:a16="http://schemas.microsoft.com/office/drawing/2014/main" id="{DD5EECA9-82FA-1745-A2CA-26C53FC2E3F8}"/>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68BDD74F-38E1-8745-8DEE-57BBFD6B66B3}"/>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40799255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D32B1268-1EFF-1747-AC13-92B0E8ABD3B3}"/>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BDAD6F66-C763-124B-830E-E0252845E544}"/>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DE87B551-EA0D-E145-8945-7305CC1FE8DB}"/>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F5ED539F-6017-7845-B903-45C373A2EBC9}"/>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6" name="Segnaposto piè di pagina 5">
            <a:extLst>
              <a:ext uri="{FF2B5EF4-FFF2-40B4-BE49-F238E27FC236}">
                <a16:creationId xmlns:a16="http://schemas.microsoft.com/office/drawing/2014/main" id="{10563676-4B17-1C45-893A-614EA68BDF87}"/>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62467C8D-0788-F44D-B924-CACF9A42D0FB}"/>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28133678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227C46B-163E-C34B-AE81-DAD42CCFE487}"/>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727289C8-A3E7-DC4C-A5B7-4600FCAD3F2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7843C3DB-BFD3-F340-A387-F98929E77D78}"/>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73501C2A-AFC1-0547-8477-E0B69AFE265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6AB58966-98EC-EA43-B0B7-97562CC3ED69}"/>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502FF5E3-060E-D54C-AEB3-FDE0ABEF8279}"/>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8" name="Segnaposto piè di pagina 7">
            <a:extLst>
              <a:ext uri="{FF2B5EF4-FFF2-40B4-BE49-F238E27FC236}">
                <a16:creationId xmlns:a16="http://schemas.microsoft.com/office/drawing/2014/main" id="{4DC0917F-5048-7343-8EB4-D696C6B5C091}"/>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314B26D1-C8C0-1B4A-924E-53BF1978952D}"/>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41993139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34351BF-D144-AD43-BE75-3B6471553862}"/>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5F518CD9-BCCE-9243-BE71-54E07A5BE9D6}"/>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4" name="Segnaposto piè di pagina 3">
            <a:extLst>
              <a:ext uri="{FF2B5EF4-FFF2-40B4-BE49-F238E27FC236}">
                <a16:creationId xmlns:a16="http://schemas.microsoft.com/office/drawing/2014/main" id="{C997FD82-2D47-D345-B175-54948CED5EA1}"/>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B64DA00D-F195-BA46-86D6-9CA1714E1A33}"/>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5993153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EDB112AD-1C8D-6849-B4E4-E2F17F155B9C}"/>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3" name="Segnaposto piè di pagina 2">
            <a:extLst>
              <a:ext uri="{FF2B5EF4-FFF2-40B4-BE49-F238E27FC236}">
                <a16:creationId xmlns:a16="http://schemas.microsoft.com/office/drawing/2014/main" id="{F160D80A-C20D-FF45-A3D7-29BB9BA8504F}"/>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C8B64331-4AFC-004D-8769-5173CE57ED7F}"/>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4670406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995AE27-0D8C-5243-B408-E2E538F8884E}"/>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E2A072AD-8EB2-FE44-9AD0-CCAAFA4ADE2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55A4683C-FCA8-BA4F-97FB-8ED22CBA3BA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F2366212-CE06-1F48-9E10-73DE3A4C4C08}"/>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6" name="Segnaposto piè di pagina 5">
            <a:extLst>
              <a:ext uri="{FF2B5EF4-FFF2-40B4-BE49-F238E27FC236}">
                <a16:creationId xmlns:a16="http://schemas.microsoft.com/office/drawing/2014/main" id="{9DEA36BD-B5F6-E240-B7EA-A4E6CC6A6563}"/>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F87E5740-BC68-2643-A019-0DFE58E749EA}"/>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15472127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D768B489-693F-B047-A94D-274F3F9DAC39}"/>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FACAEFC0-4E63-8C40-BB87-DA8FA25BAA7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596EA596-42DB-724C-8AEF-BDFCC338DCE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8BD24548-1F86-714D-810C-4A2F9D213732}"/>
              </a:ext>
            </a:extLst>
          </p:cNvPr>
          <p:cNvSpPr>
            <a:spLocks noGrp="1"/>
          </p:cNvSpPr>
          <p:nvPr>
            <p:ph type="dt" sz="half" idx="10"/>
          </p:nvPr>
        </p:nvSpPr>
        <p:spPr/>
        <p:txBody>
          <a:bodyPr/>
          <a:lstStyle/>
          <a:p>
            <a:fld id="{C1CB5DA3-3258-EC4E-9DBD-5833747EDCDF}" type="datetimeFigureOut">
              <a:rPr lang="it-IT" smtClean="0"/>
              <a:t>09/05/22</a:t>
            </a:fld>
            <a:endParaRPr lang="it-IT"/>
          </a:p>
        </p:txBody>
      </p:sp>
      <p:sp>
        <p:nvSpPr>
          <p:cNvPr id="6" name="Segnaposto piè di pagina 5">
            <a:extLst>
              <a:ext uri="{FF2B5EF4-FFF2-40B4-BE49-F238E27FC236}">
                <a16:creationId xmlns:a16="http://schemas.microsoft.com/office/drawing/2014/main" id="{9D10032C-DDE1-1B4F-8EA4-83282CA552B0}"/>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F1995E9F-7E45-AE45-9510-262097151ED5}"/>
              </a:ext>
            </a:extLst>
          </p:cNvPr>
          <p:cNvSpPr>
            <a:spLocks noGrp="1"/>
          </p:cNvSpPr>
          <p:nvPr>
            <p:ph type="sldNum" sz="quarter" idx="12"/>
          </p:nvPr>
        </p:nvSpPr>
        <p:spPr/>
        <p:txBody>
          <a:bodyPr/>
          <a:lstStyle/>
          <a:p>
            <a:fld id="{64E08D3D-A7FE-254F-A6C2-9BAF36105687}" type="slidenum">
              <a:rPr lang="it-IT" smtClean="0"/>
              <a:t>‹N›</a:t>
            </a:fld>
            <a:endParaRPr lang="it-IT"/>
          </a:p>
        </p:txBody>
      </p:sp>
    </p:spTree>
    <p:extLst>
      <p:ext uri="{BB962C8B-B14F-4D97-AF65-F5344CB8AC3E}">
        <p14:creationId xmlns:p14="http://schemas.microsoft.com/office/powerpoint/2010/main" val="38286802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495686E8-C8F6-9A45-B1D7-8C6222FDDE0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03F1FAD7-1827-6948-A338-50C86A6F8AF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2F2BD42A-95A1-9442-8BD4-66E79020F9E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1CB5DA3-3258-EC4E-9DBD-5833747EDCDF}" type="datetimeFigureOut">
              <a:rPr lang="it-IT" smtClean="0"/>
              <a:t>09/05/22</a:t>
            </a:fld>
            <a:endParaRPr lang="it-IT"/>
          </a:p>
        </p:txBody>
      </p:sp>
      <p:sp>
        <p:nvSpPr>
          <p:cNvPr id="5" name="Segnaposto piè di pagina 4">
            <a:extLst>
              <a:ext uri="{FF2B5EF4-FFF2-40B4-BE49-F238E27FC236}">
                <a16:creationId xmlns:a16="http://schemas.microsoft.com/office/drawing/2014/main" id="{354F52B2-9354-9E4E-875C-68438270DF7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AAD77487-F2D3-C84B-AEED-F5D13C8FCEF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4E08D3D-A7FE-254F-A6C2-9BAF36105687}" type="slidenum">
              <a:rPr lang="it-IT" smtClean="0"/>
              <a:t>‹N›</a:t>
            </a:fld>
            <a:endParaRPr lang="it-IT"/>
          </a:p>
        </p:txBody>
      </p:sp>
    </p:spTree>
    <p:extLst>
      <p:ext uri="{BB962C8B-B14F-4D97-AF65-F5344CB8AC3E}">
        <p14:creationId xmlns:p14="http://schemas.microsoft.com/office/powerpoint/2010/main" val="402069757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ttangolo 7">
            <a:extLst>
              <a:ext uri="{FF2B5EF4-FFF2-40B4-BE49-F238E27FC236}">
                <a16:creationId xmlns:a16="http://schemas.microsoft.com/office/drawing/2014/main" id="{952537B7-B5C8-B544-AA1D-C29D6B534BE2}"/>
              </a:ext>
            </a:extLst>
          </p:cNvPr>
          <p:cNvSpPr/>
          <p:nvPr/>
        </p:nvSpPr>
        <p:spPr>
          <a:xfrm>
            <a:off x="464876" y="5816600"/>
            <a:ext cx="11727124" cy="461665"/>
          </a:xfrm>
          <a:prstGeom prst="rect">
            <a:avLst/>
          </a:prstGeom>
        </p:spPr>
        <p:txBody>
          <a:bodyPr wrap="square">
            <a:spAutoFit/>
          </a:bodyPr>
          <a:lstStyle/>
          <a:p>
            <a:r>
              <a:rPr lang="en-US" sz="1200" b="1"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Supplementary Fig. 3</a:t>
            </a:r>
            <a:r>
              <a:rPr lang="en-US"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Genotypic variability of the 185 wheat genotypes. Loading plot of the first (PC1) and second (PC2) principal components showing the variation among individuals. Based on Triticum ssp., genotypes are represented by different colored symbols indicated in the legend</a:t>
            </a:r>
            <a:r>
              <a:rPr lang="en-US" sz="120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pic>
        <p:nvPicPr>
          <p:cNvPr id="3" name="Immagine 2">
            <a:extLst>
              <a:ext uri="{FF2B5EF4-FFF2-40B4-BE49-F238E27FC236}">
                <a16:creationId xmlns:a16="http://schemas.microsoft.com/office/drawing/2014/main" id="{6130C441-1D1E-D643-95A0-1ED26AFECD07}"/>
              </a:ext>
            </a:extLst>
          </p:cNvPr>
          <p:cNvPicPr>
            <a:picLocks noChangeAspect="1"/>
          </p:cNvPicPr>
          <p:nvPr/>
        </p:nvPicPr>
        <p:blipFill>
          <a:blip r:embed="rId2"/>
          <a:stretch>
            <a:fillRect/>
          </a:stretch>
        </p:blipFill>
        <p:spPr>
          <a:xfrm>
            <a:off x="2672080" y="230517"/>
            <a:ext cx="6299200" cy="5586083"/>
          </a:xfrm>
          <a:prstGeom prst="rect">
            <a:avLst/>
          </a:prstGeom>
        </p:spPr>
      </p:pic>
    </p:spTree>
    <p:extLst>
      <p:ext uri="{BB962C8B-B14F-4D97-AF65-F5344CB8AC3E}">
        <p14:creationId xmlns:p14="http://schemas.microsoft.com/office/powerpoint/2010/main" val="4209016668"/>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5</TotalTime>
  <Words>51</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1</vt:i4>
      </vt:variant>
    </vt:vector>
  </HeadingPairs>
  <TitlesOfParts>
    <vt:vector size="6" baseType="lpstr">
      <vt:lpstr>Arial</vt:lpstr>
      <vt:lpstr>Calibri</vt:lpstr>
      <vt:lpstr>Calibri Light</vt:lpstr>
      <vt:lpstr>Times New Roman</vt:lpstr>
      <vt:lpstr>Tema di Office</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Salvatore Esposito</dc:creator>
  <cp:lastModifiedBy>Salvatore Esposito</cp:lastModifiedBy>
  <cp:revision>3</cp:revision>
  <dcterms:created xsi:type="dcterms:W3CDTF">2022-05-04T07:21:17Z</dcterms:created>
  <dcterms:modified xsi:type="dcterms:W3CDTF">2022-05-09T07:49:04Z</dcterms:modified>
</cp:coreProperties>
</file>